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68384" autoAdjust="0"/>
  </p:normalViewPr>
  <p:slideViewPr>
    <p:cSldViewPr snapToObjects="1">
      <p:cViewPr>
        <p:scale>
          <a:sx n="100" d="100"/>
          <a:sy n="100" d="100"/>
        </p:scale>
        <p:origin x="-1014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pepper\homestd\My%20Documents\experiments\mutant%20screen%20year%203\ler0%20background%20mutants%20inc%20dmr\dmr%20mutants\homoserine%20inhibition\Wheat%20inhibition%20rep2\Wheat%20inhibition%20scoring%20rep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pepper\homestd\My%20Documents\experiments\mutant%20screen%20year%203\ler0%20background%20mutants%20inc%20dmr\dmr%20mutants\homoserine%20inhibition\Wheat%20inhibition%20rep2\Wheat%20inhibition%20scoring%20rep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pepper\homestd\My%20Documents\experiments\mutant%20screen%20year%203\ler0%20background%20mutants%20inc%20dmr\dmr%20mutants\homoserine%20inhibition\Wheat%20inhibition%20rep2\Wheat%20inhibition%20scoring%20rep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pepper\homestd\My%20Documents\experiments\mutant%20screen%20year%203\ler0%20background%20mutants%20inc%20dmr\dmr%20mutants\homoserine%20inhibition\Wheat%20inhibition%20rep2\Wheat%20inhibition%20scoring%20rep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v>10dpi</c:v>
          </c:tx>
          <c:spPr>
            <a:solidFill>
              <a:schemeClr val="tx1">
                <a:lumMod val="65000"/>
                <a:lumOff val="3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C$41:$C$43</c:f>
                <c:numCache>
                  <c:formatCode>General</c:formatCode>
                  <c:ptCount val="3"/>
                  <c:pt idx="0">
                    <c:v>0.56273143387113767</c:v>
                  </c:pt>
                  <c:pt idx="1">
                    <c:v>2.7537852736430528</c:v>
                  </c:pt>
                  <c:pt idx="2">
                    <c:v>0.76376261582597327</c:v>
                  </c:pt>
                </c:numCache>
              </c:numRef>
            </c:plus>
            <c:minus>
              <c:numRef>
                <c:f>Sheet1!$C$41:$C$43</c:f>
                <c:numCache>
                  <c:formatCode>General</c:formatCode>
                  <c:ptCount val="3"/>
                  <c:pt idx="0">
                    <c:v>0.56273143387113767</c:v>
                  </c:pt>
                  <c:pt idx="1">
                    <c:v>2.7537852736430528</c:v>
                  </c:pt>
                  <c:pt idx="2">
                    <c:v>0.76376261582597327</c:v>
                  </c:pt>
                </c:numCache>
              </c:numRef>
            </c:minus>
          </c:errBars>
          <c:cat>
            <c:strRef>
              <c:f>Sheet1!$A$31:$A$33</c:f>
              <c:strCache>
                <c:ptCount val="3"/>
                <c:pt idx="0">
                  <c:v>Water</c:v>
                </c:pt>
                <c:pt idx="1">
                  <c:v>DHS</c:v>
                </c:pt>
                <c:pt idx="2">
                  <c:v>LHS</c:v>
                </c:pt>
              </c:strCache>
            </c:strRef>
          </c:cat>
          <c:val>
            <c:numRef>
              <c:f>Sheet1!$C$34:$C$36</c:f>
              <c:numCache>
                <c:formatCode>General</c:formatCode>
                <c:ptCount val="3"/>
                <c:pt idx="0">
                  <c:v>19.75</c:v>
                </c:pt>
                <c:pt idx="1">
                  <c:v>18.666666666666668</c:v>
                </c:pt>
                <c:pt idx="2">
                  <c:v>15.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8936320"/>
        <c:axId val="118938240"/>
      </c:barChart>
      <c:catAx>
        <c:axId val="118936320"/>
        <c:scaling>
          <c:orientation val="minMax"/>
        </c:scaling>
        <c:delete val="0"/>
        <c:axPos val="b"/>
        <c:majorTickMark val="out"/>
        <c:minorTickMark val="none"/>
        <c:tickLblPos val="nextTo"/>
        <c:crossAx val="118938240"/>
        <c:crosses val="autoZero"/>
        <c:auto val="1"/>
        <c:lblAlgn val="ctr"/>
        <c:lblOffset val="100"/>
        <c:noMultiLvlLbl val="0"/>
      </c:catAx>
      <c:valAx>
        <c:axId val="1189382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Bent awns/ ear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1893632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v>10dpi</c:v>
          </c:tx>
          <c:spPr>
            <a:solidFill>
              <a:schemeClr val="tx1">
                <a:lumMod val="65000"/>
                <a:lumOff val="3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H$43</c:f>
                <c:numCache>
                  <c:formatCode>General</c:formatCode>
                  <c:ptCount val="1"/>
                  <c:pt idx="0">
                    <c:v>0.46368092477478584</c:v>
                  </c:pt>
                </c:numCache>
              </c:numRef>
            </c:plus>
            <c:minus>
              <c:numRef>
                <c:f>Sheet1!$H$43</c:f>
                <c:numCache>
                  <c:formatCode>General</c:formatCode>
                  <c:ptCount val="1"/>
                  <c:pt idx="0">
                    <c:v>0.46368092477478584</c:v>
                  </c:pt>
                </c:numCache>
              </c:numRef>
            </c:minus>
          </c:errBars>
          <c:cat>
            <c:strRef>
              <c:f>Sheet1!$A$31:$A$33</c:f>
              <c:strCache>
                <c:ptCount val="3"/>
                <c:pt idx="0">
                  <c:v>Water</c:v>
                </c:pt>
                <c:pt idx="1">
                  <c:v>DHS</c:v>
                </c:pt>
                <c:pt idx="2">
                  <c:v>LHS</c:v>
                </c:pt>
              </c:strCache>
            </c:strRef>
          </c:cat>
          <c:val>
            <c:numRef>
              <c:f>Sheet1!$H$34:$H$36</c:f>
              <c:numCache>
                <c:formatCode>General</c:formatCode>
                <c:ptCount val="3"/>
                <c:pt idx="0">
                  <c:v>9.4</c:v>
                </c:pt>
                <c:pt idx="1">
                  <c:v>8.75</c:v>
                </c:pt>
                <c:pt idx="2">
                  <c:v>7.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226816"/>
        <c:axId val="130417024"/>
      </c:barChart>
      <c:catAx>
        <c:axId val="130226816"/>
        <c:scaling>
          <c:orientation val="minMax"/>
        </c:scaling>
        <c:delete val="0"/>
        <c:axPos val="b"/>
        <c:majorTickMark val="out"/>
        <c:minorTickMark val="none"/>
        <c:tickLblPos val="nextTo"/>
        <c:crossAx val="130417024"/>
        <c:crosses val="autoZero"/>
        <c:auto val="1"/>
        <c:lblAlgn val="ctr"/>
        <c:lblOffset val="100"/>
        <c:noMultiLvlLbl val="0"/>
      </c:catAx>
      <c:valAx>
        <c:axId val="13041702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bleached spikelets/ear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3022681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(Sheet1!$P$6,Sheet1!$P$10,Sheet1!$P$15)</c:f>
                <c:numCache>
                  <c:formatCode>General</c:formatCode>
                  <c:ptCount val="3"/>
                  <c:pt idx="0">
                    <c:v>4.4013179844223982E-2</c:v>
                  </c:pt>
                  <c:pt idx="1">
                    <c:v>3.6968455021364685E-2</c:v>
                  </c:pt>
                  <c:pt idx="2">
                    <c:v>4.0323690307311831E-2</c:v>
                  </c:pt>
                </c:numCache>
              </c:numRef>
            </c:plus>
            <c:minus>
              <c:numRef>
                <c:f>(Sheet1!$P$6,Sheet1!$P$10,Sheet1!$P$15)</c:f>
                <c:numCache>
                  <c:formatCode>General</c:formatCode>
                  <c:ptCount val="3"/>
                  <c:pt idx="0">
                    <c:v>4.4013179844223982E-2</c:v>
                  </c:pt>
                  <c:pt idx="1">
                    <c:v>3.6968455021364685E-2</c:v>
                  </c:pt>
                  <c:pt idx="2">
                    <c:v>4.0323690307311831E-2</c:v>
                  </c:pt>
                </c:numCache>
              </c:numRef>
            </c:minus>
          </c:errBars>
          <c:cat>
            <c:strRef>
              <c:f>(Sheet1!$L$6,Sheet1!$L$10,Sheet1!$L$15)</c:f>
              <c:strCache>
                <c:ptCount val="3"/>
                <c:pt idx="0">
                  <c:v>H2O</c:v>
                </c:pt>
                <c:pt idx="1">
                  <c:v>DHS</c:v>
                </c:pt>
                <c:pt idx="2">
                  <c:v>LHS</c:v>
                </c:pt>
              </c:strCache>
            </c:strRef>
          </c:cat>
          <c:val>
            <c:numRef>
              <c:f>(Sheet1!$O$6,Sheet1!$O$10,Sheet1!$O$15)</c:f>
              <c:numCache>
                <c:formatCode>General</c:formatCode>
                <c:ptCount val="3"/>
                <c:pt idx="0">
                  <c:v>0.31540000000000001</c:v>
                </c:pt>
                <c:pt idx="1">
                  <c:v>0.35500000000000004</c:v>
                </c:pt>
                <c:pt idx="2">
                  <c:v>0.424000000000000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740992"/>
        <c:axId val="130742912"/>
      </c:barChart>
      <c:catAx>
        <c:axId val="1307409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reatment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30742912"/>
        <c:crosses val="autoZero"/>
        <c:auto val="1"/>
        <c:lblAlgn val="ctr"/>
        <c:lblOffset val="100"/>
        <c:noMultiLvlLbl val="0"/>
      </c:catAx>
      <c:valAx>
        <c:axId val="13074291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smtClean="0"/>
                  <a:t>grain </a:t>
                </a:r>
                <a:r>
                  <a:rPr lang="en-US" dirty="0"/>
                  <a:t>weight per plant (g)</a:t>
                </a: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crossAx val="13074099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(Sheet1!$R$6,Sheet1!$R$10,Sheet1!$R$15)</c:f>
                <c:numCache>
                  <c:formatCode>General</c:formatCode>
                  <c:ptCount val="3"/>
                  <c:pt idx="0">
                    <c:v>1.6124515496597098</c:v>
                  </c:pt>
                  <c:pt idx="1">
                    <c:v>1.1902380714238083</c:v>
                  </c:pt>
                  <c:pt idx="2">
                    <c:v>1.1401754250991378</c:v>
                  </c:pt>
                </c:numCache>
              </c:numRef>
            </c:plus>
            <c:minus>
              <c:numRef>
                <c:f>(Sheet1!$R$6,Sheet1!$R$10,Sheet1!$R$15)</c:f>
                <c:numCache>
                  <c:formatCode>General</c:formatCode>
                  <c:ptCount val="3"/>
                  <c:pt idx="0">
                    <c:v>1.6124515496597098</c:v>
                  </c:pt>
                  <c:pt idx="1">
                    <c:v>1.1902380714238083</c:v>
                  </c:pt>
                  <c:pt idx="2">
                    <c:v>1.1401754250991378</c:v>
                  </c:pt>
                </c:numCache>
              </c:numRef>
            </c:minus>
          </c:errBars>
          <c:cat>
            <c:strRef>
              <c:f>(Sheet1!$L$6,Sheet1!$L$10,Sheet1!$L$15)</c:f>
              <c:strCache>
                <c:ptCount val="3"/>
                <c:pt idx="0">
                  <c:v>H2O</c:v>
                </c:pt>
                <c:pt idx="1">
                  <c:v>DHS</c:v>
                </c:pt>
                <c:pt idx="2">
                  <c:v>LHS</c:v>
                </c:pt>
              </c:strCache>
            </c:strRef>
          </c:cat>
          <c:val>
            <c:numRef>
              <c:f>(Sheet1!$Q$6,Sheet1!$Q$10,Sheet1!$Q$15)</c:f>
              <c:numCache>
                <c:formatCode>General</c:formatCode>
                <c:ptCount val="3"/>
                <c:pt idx="0">
                  <c:v>27</c:v>
                </c:pt>
                <c:pt idx="1">
                  <c:v>28.5</c:v>
                </c:pt>
                <c:pt idx="2">
                  <c:v>3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755584"/>
        <c:axId val="130761856"/>
      </c:barChart>
      <c:catAx>
        <c:axId val="13075558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reatment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30761856"/>
        <c:crosses val="autoZero"/>
        <c:auto val="1"/>
        <c:lblAlgn val="ctr"/>
        <c:lblOffset val="100"/>
        <c:noMultiLvlLbl val="0"/>
      </c:catAx>
      <c:valAx>
        <c:axId val="13076185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smtClean="0"/>
                  <a:t> </a:t>
                </a:r>
                <a:r>
                  <a:rPr lang="en-US" dirty="0"/>
                  <a:t>grain number per plant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3075558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3062C3-B108-4DE4-93CF-ECEA64284BE7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51737A-AC2D-4E35-A350-443A7C04B4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92204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mtClean="0"/>
              <a:t>Supplementary</a:t>
            </a:r>
            <a:r>
              <a:rPr lang="en-GB" baseline="0" smtClean="0"/>
              <a:t> Figure 6: </a:t>
            </a:r>
            <a:r>
              <a:rPr lang="en-GB" dirty="0" smtClean="0"/>
              <a:t>Effect </a:t>
            </a:r>
            <a:r>
              <a:rPr lang="en-GB" dirty="0" smtClean="0"/>
              <a:t>of L-homoserine application on Fusarium infection of wheat. Spikes of wheat cultivar Apogee were point inoculated with F. graminearum and then treated with either L-homoserine (LHS) D-homoserine (DHS) or water for 7 days. The number of bent awns (a) and bleached spikelets (b) along with grain weight (c) and number (d) per plant was assessed at 10dpi. (*)  The number of bleached spikelets was significantly lower in LHS treated plants (p=0.03). No statistically significant difference between treatments was found for other parameters (ANOVA, p = &gt; 0.05). Bar = standard error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51737A-AC2D-4E35-A350-443A7C04B441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42788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3567-7A0E-46A3-9A7B-624605C435F0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6851A-6AC4-4656-80C8-288B7FF84F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45418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3567-7A0E-46A3-9A7B-624605C435F0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6851A-6AC4-4656-80C8-288B7FF84F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88195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3567-7A0E-46A3-9A7B-624605C435F0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6851A-6AC4-4656-80C8-288B7FF84F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8408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3567-7A0E-46A3-9A7B-624605C435F0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6851A-6AC4-4656-80C8-288B7FF84F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88961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3567-7A0E-46A3-9A7B-624605C435F0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6851A-6AC4-4656-80C8-288B7FF84F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08197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3567-7A0E-46A3-9A7B-624605C435F0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6851A-6AC4-4656-80C8-288B7FF84F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09933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3567-7A0E-46A3-9A7B-624605C435F0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6851A-6AC4-4656-80C8-288B7FF84F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21310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3567-7A0E-46A3-9A7B-624605C435F0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6851A-6AC4-4656-80C8-288B7FF84F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1037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3567-7A0E-46A3-9A7B-624605C435F0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6851A-6AC4-4656-80C8-288B7FF84F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74502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3567-7A0E-46A3-9A7B-624605C435F0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6851A-6AC4-4656-80C8-288B7FF84F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1398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3567-7A0E-46A3-9A7B-624605C435F0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6851A-6AC4-4656-80C8-288B7FF84F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4949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E73567-7A0E-46A3-9A7B-624605C435F0}" type="datetimeFigureOut">
              <a:rPr lang="en-GB" smtClean="0"/>
              <a:t>03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66851A-6AC4-4656-80C8-288B7FF84F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7957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-99391" y="0"/>
            <a:ext cx="6975399" cy="4788024"/>
            <a:chOff x="-99391" y="0"/>
            <a:chExt cx="6975399" cy="4788024"/>
          </a:xfrm>
        </p:grpSpPr>
        <p:grpSp>
          <p:nvGrpSpPr>
            <p:cNvPr id="12" name="Group 11"/>
            <p:cNvGrpSpPr/>
            <p:nvPr/>
          </p:nvGrpSpPr>
          <p:grpSpPr>
            <a:xfrm>
              <a:off x="-99391" y="0"/>
              <a:ext cx="6975399" cy="4788024"/>
              <a:chOff x="-99391" y="0"/>
              <a:chExt cx="6975399" cy="4788024"/>
            </a:xfrm>
          </p:grpSpPr>
          <p:graphicFrame>
            <p:nvGraphicFramePr>
              <p:cNvPr id="4" name="Chart 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207301634"/>
                  </p:ext>
                </p:extLst>
              </p:nvPr>
            </p:nvGraphicFramePr>
            <p:xfrm>
              <a:off x="1" y="11579"/>
              <a:ext cx="3356991" cy="232817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5" name="Chart 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445330799"/>
                  </p:ext>
                </p:extLst>
              </p:nvPr>
            </p:nvGraphicFramePr>
            <p:xfrm>
              <a:off x="3356992" y="0"/>
              <a:ext cx="3501008" cy="233975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6" name="Chart 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857593514"/>
                  </p:ext>
                </p:extLst>
              </p:nvPr>
            </p:nvGraphicFramePr>
            <p:xfrm>
              <a:off x="-99391" y="2339752"/>
              <a:ext cx="3456384" cy="244827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aphicFrame>
            <p:nvGraphicFramePr>
              <p:cNvPr id="7" name="Chart 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460939858"/>
                  </p:ext>
                </p:extLst>
              </p:nvPr>
            </p:nvGraphicFramePr>
            <p:xfrm>
              <a:off x="3356992" y="2195736"/>
              <a:ext cx="3519016" cy="259228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8" name="TextBox 7"/>
              <p:cNvSpPr txBox="1"/>
              <p:nvPr/>
            </p:nvSpPr>
            <p:spPr>
              <a:xfrm>
                <a:off x="1" y="11579"/>
                <a:ext cx="33265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 smtClean="0"/>
                  <a:t>a</a:t>
                </a:r>
                <a:endParaRPr lang="en-GB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3356992" y="2155086"/>
                <a:ext cx="33265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 smtClean="0"/>
                  <a:t>d</a:t>
                </a:r>
                <a:endParaRPr lang="en-GB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3422948" y="11579"/>
                <a:ext cx="33265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/>
                  <a:t>b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1" y="2155086"/>
                <a:ext cx="33265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/>
                  <a:t>c</a:t>
                </a:r>
              </a:p>
            </p:txBody>
          </p:sp>
        </p:grpSp>
        <p:sp>
          <p:nvSpPr>
            <p:cNvPr id="13" name="TextBox 12"/>
            <p:cNvSpPr txBox="1"/>
            <p:nvPr/>
          </p:nvSpPr>
          <p:spPr>
            <a:xfrm>
              <a:off x="6093296" y="348645"/>
              <a:ext cx="3326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138957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8</TotalTime>
  <Words>143</Words>
  <Application>Microsoft Office PowerPoint</Application>
  <PresentationFormat>On-screen Show (4:3)</PresentationFormat>
  <Paragraphs>1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Rothamsted Resear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 Brewer (RRes-Roth)</dc:creator>
  <cp:lastModifiedBy>Helen Brewer (RRes-Roth)</cp:lastModifiedBy>
  <cp:revision>10</cp:revision>
  <dcterms:created xsi:type="dcterms:W3CDTF">2014-08-08T15:24:14Z</dcterms:created>
  <dcterms:modified xsi:type="dcterms:W3CDTF">2014-12-03T14:37:23Z</dcterms:modified>
</cp:coreProperties>
</file>